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4" r:id="rId3"/>
    <p:sldId id="277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4" autoAdjust="0"/>
    <p:restoredTop sz="94660"/>
  </p:normalViewPr>
  <p:slideViewPr>
    <p:cSldViewPr snapToGrid="0">
      <p:cViewPr varScale="1">
        <p:scale>
          <a:sx n="68" d="100"/>
          <a:sy n="68" d="100"/>
        </p:scale>
        <p:origin x="65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417412F-B969-43A7-8D0E-491B57FAC5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3FB3AD6-A91A-4FBA-82AF-2024FAF80D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8A12367-F202-416A-A02B-F23B439E3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010F0FA-1D5B-44D4-8080-9F79F091B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3DEA9BB-CDBF-4F47-864A-BBB829ED6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4732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E981D9-88C2-41CA-8467-A83CAC8448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902D8EC-3513-445C-B3D2-F8033D1113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DCF6B50-A1B4-4FC0-A201-C602F49EA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A064D9E-13D9-4498-9DF8-9FB6BF011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90155D5-CBED-4C8B-A075-B331AA802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7119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E023443-D385-4E8B-AA81-1EEEDB79B2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D96489A-9EC0-402B-9A92-47FDCAB95F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F1DDFD1-514C-475A-8249-28B335B09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6476C0A-18DA-4382-BF53-7E71A8E3C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1F24C91-994F-4C94-BF9F-5A07A6997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2818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D3581CD-34EB-47C4-9ED6-C288ADC445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59AFE61-8881-4314-A8F8-E7A57E3B76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A08AE17-4975-4C83-8C7B-C1025876CB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8734FCB-DE28-4A5D-8F11-0EAE69B75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06AE62A-4E2C-453A-9A99-491611D65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0068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EDD8459-5C4A-4645-BC69-49EA47E241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A7554B2-FC9D-48C2-AABC-5AEB6F3AE3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40AF95D-FDDD-4855-96E3-14589872E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0EF6DFE-7368-4677-96D4-96910651A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C1EDE07-1936-40D6-82FA-B96752EFE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9788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E5E9205-28A4-4C75-B4A4-A3811AC4AC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06D5769-6ECD-43A2-A3FA-CC14BC7A24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DE8890F-E43F-493F-B2CF-D6EA3D88DD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B58A111-DDD8-4EAE-9402-6813B9A74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511A5B5-7E5A-408D-805E-A396097F4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7728FE4-706B-477D-BB9A-E77120361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2949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5CFA39-6AF1-4E86-BAA1-C22FA418EE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F24439B-2D38-4830-BBB8-9B7058E4D3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FAD8F4F-5025-482F-9083-7D5AA56E8C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20D697A-CA7A-4488-BE5B-DA552F2979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123C0124-4A99-4C21-88D8-19C8E6EB15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22E0798-C00C-4277-88F1-8E00E421FA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D5C48B97-2CFB-49E5-A952-56CA41B9D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4D23EA27-0964-47BD-A658-30CD04AFF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484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0666C73-0B1A-40C6-BE8C-D4A4EF539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227AC29-909D-4DFC-9220-15A1F9587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B8DDCBB-16F9-43BA-BB9D-00A0D5830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1EBFE4B-0CB9-4DE7-BB7F-9A0D7F1D2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7723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5C4B0330-EDA5-4E4C-935D-E5047D35B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F7C3739-4679-4B9B-A534-7148C072A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6A8447D-B3B2-4F7F-BB9F-8AEBFDFC2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5354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C4DA323-0A28-4F68-9F6D-EFA9C6CF4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3994DDB-1AE9-43BF-8A05-FEEDC92427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DD6D012-4786-43EF-8CF8-11AED4F3CF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6BA3999-78D5-428C-ABD0-F099D243E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D590F9F-0C11-4A92-878A-E25C169279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6BB64B5-1D61-4F8F-8302-A946C3ABB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443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3E0CF3E-57B0-455B-8EAF-900BD2EE4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D4829188-189D-4751-86F9-5DD91F47C3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80755EE-BB8C-4CD8-9020-F2A085EE81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81624E6-DD18-4776-A1FC-DDC12C3C2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039D834-D0ED-42FA-8BC4-86D0B969D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2E17DE7-401E-437F-B54D-F148D8B34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6632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E7CC832E-2389-452A-BB86-FEE4A9CB00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29DA841-4A35-4E5E-9924-786E2456B4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5927B23-DFC4-4EED-BFA5-0E830750CD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2835B-A6DB-4BCB-A36B-C945A116850C}" type="datetimeFigureOut">
              <a:rPr lang="es-ES" smtClean="0"/>
              <a:t>01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994229F-E307-4929-A1EB-E433DCB41C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8CBAE3A-E4B5-47FB-B979-E434B02B1C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EBA9B-9628-42FA-900F-B5CA92092F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2535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4">
            <a:extLst>
              <a:ext uri="{FF2B5EF4-FFF2-40B4-BE49-F238E27FC236}">
                <a16:creationId xmlns:a16="http://schemas.microsoft.com/office/drawing/2014/main" id="{BA1327A6-3BDB-47C2-4A6A-7B26C048A111}"/>
              </a:ext>
            </a:extLst>
          </p:cNvPr>
          <p:cNvGrpSpPr/>
          <p:nvPr/>
        </p:nvGrpSpPr>
        <p:grpSpPr>
          <a:xfrm>
            <a:off x="205859" y="360082"/>
            <a:ext cx="9283253" cy="5762266"/>
            <a:chOff x="205859" y="360082"/>
            <a:chExt cx="9283253" cy="5762266"/>
          </a:xfrm>
        </p:grpSpPr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8640E4FC-E8F2-A892-1EE7-5C53F181FCB9}"/>
                </a:ext>
              </a:extLst>
            </p:cNvPr>
            <p:cNvGrpSpPr/>
            <p:nvPr/>
          </p:nvGrpSpPr>
          <p:grpSpPr>
            <a:xfrm>
              <a:off x="205859" y="360082"/>
              <a:ext cx="9283253" cy="5762266"/>
              <a:chOff x="205859" y="360082"/>
              <a:chExt cx="9283253" cy="5762266"/>
            </a:xfrm>
          </p:grpSpPr>
          <p:sp>
            <p:nvSpPr>
              <p:cNvPr id="17" name="10 CuadroTexto">
                <a:extLst>
                  <a:ext uri="{FF2B5EF4-FFF2-40B4-BE49-F238E27FC236}">
                    <a16:creationId xmlns:a16="http://schemas.microsoft.com/office/drawing/2014/main" id="{8580B882-BF11-4392-827E-2D1B059ED94A}"/>
                  </a:ext>
                </a:extLst>
              </p:cNvPr>
              <p:cNvSpPr txBox="1"/>
              <p:nvPr/>
            </p:nvSpPr>
            <p:spPr>
              <a:xfrm>
                <a:off x="7472888" y="2128906"/>
                <a:ext cx="201622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ubulin (55 </a:t>
                </a:r>
                <a:r>
                  <a:rPr lang="en-US" sz="15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8" name="11 CuadroTexto">
                <a:extLst>
                  <a:ext uri="{FF2B5EF4-FFF2-40B4-BE49-F238E27FC236}">
                    <a16:creationId xmlns:a16="http://schemas.microsoft.com/office/drawing/2014/main" id="{5152A4D4-1803-43BC-86B1-77D542DFAF18}"/>
                  </a:ext>
                </a:extLst>
              </p:cNvPr>
              <p:cNvSpPr txBox="1"/>
              <p:nvPr/>
            </p:nvSpPr>
            <p:spPr>
              <a:xfrm>
                <a:off x="1984390" y="2737338"/>
                <a:ext cx="1556355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CR5 (46 </a:t>
                </a:r>
                <a:r>
                  <a:rPr lang="en-US" sz="15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sz="1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2" name="CuadroTexto 1">
                <a:extLst>
                  <a:ext uri="{FF2B5EF4-FFF2-40B4-BE49-F238E27FC236}">
                    <a16:creationId xmlns:a16="http://schemas.microsoft.com/office/drawing/2014/main" id="{918439DD-9992-2CE2-9FAC-E6E304B38AAE}"/>
                  </a:ext>
                </a:extLst>
              </p:cNvPr>
              <p:cNvSpPr txBox="1"/>
              <p:nvPr/>
            </p:nvSpPr>
            <p:spPr>
              <a:xfrm>
                <a:off x="205859" y="360082"/>
                <a:ext cx="181473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2400" b="1" dirty="0"/>
                  <a:t>Figure 4</a:t>
                </a:r>
              </a:p>
            </p:txBody>
          </p:sp>
          <p:sp>
            <p:nvSpPr>
              <p:cNvPr id="8" name="CuadroTexto 7">
                <a:extLst>
                  <a:ext uri="{FF2B5EF4-FFF2-40B4-BE49-F238E27FC236}">
                    <a16:creationId xmlns:a16="http://schemas.microsoft.com/office/drawing/2014/main" id="{4812499F-20D1-1DBF-BDA1-8301C9BD9005}"/>
                  </a:ext>
                </a:extLst>
              </p:cNvPr>
              <p:cNvSpPr txBox="1"/>
              <p:nvPr/>
            </p:nvSpPr>
            <p:spPr>
              <a:xfrm>
                <a:off x="3101233" y="5199018"/>
                <a:ext cx="2910359" cy="9233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Both (CCR5 and Tubulin) cropped from different parts of the different gels. </a:t>
                </a:r>
              </a:p>
            </p:txBody>
          </p:sp>
        </p:grpSp>
        <p:sp>
          <p:nvSpPr>
            <p:cNvPr id="3" name="8 CuadroTexto">
              <a:extLst>
                <a:ext uri="{FF2B5EF4-FFF2-40B4-BE49-F238E27FC236}">
                  <a16:creationId xmlns:a16="http://schemas.microsoft.com/office/drawing/2014/main" id="{B637C558-2FC8-5356-C920-C429E3060FC9}"/>
                </a:ext>
              </a:extLst>
            </p:cNvPr>
            <p:cNvSpPr txBox="1"/>
            <p:nvPr/>
          </p:nvSpPr>
          <p:spPr>
            <a:xfrm>
              <a:off x="3343398" y="4787371"/>
              <a:ext cx="22973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C // NOT // NOT+USGET</a:t>
              </a:r>
            </a:p>
          </p:txBody>
        </p:sp>
      </p:grpSp>
      <p:pic>
        <p:nvPicPr>
          <p:cNvPr id="10" name="Imagen 9">
            <a:extLst>
              <a:ext uri="{FF2B5EF4-FFF2-40B4-BE49-F238E27FC236}">
                <a16:creationId xmlns:a16="http://schemas.microsoft.com/office/drawing/2014/main" id="{83E41F38-BF72-EB86-E96C-D971CE9F700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001" t="21240" r="33675" b="29626"/>
          <a:stretch/>
        </p:blipFill>
        <p:spPr>
          <a:xfrm>
            <a:off x="3784514" y="559173"/>
            <a:ext cx="1680683" cy="3632200"/>
          </a:xfrm>
          <a:prstGeom prst="rect">
            <a:avLst/>
          </a:prstGeom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524C5EE3-B088-4354-141F-FB953C1B958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7808" t="28966" r="14566" b="15308"/>
          <a:stretch/>
        </p:blipFill>
        <p:spPr>
          <a:xfrm>
            <a:off x="5708966" y="559173"/>
            <a:ext cx="1814733" cy="3821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05098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>
            <a:extLst>
              <a:ext uri="{FF2B5EF4-FFF2-40B4-BE49-F238E27FC236}">
                <a16:creationId xmlns:a16="http://schemas.microsoft.com/office/drawing/2014/main" id="{D4DBCB69-C798-BC10-D46C-9751C06F7064}"/>
              </a:ext>
            </a:extLst>
          </p:cNvPr>
          <p:cNvGrpSpPr/>
          <p:nvPr/>
        </p:nvGrpSpPr>
        <p:grpSpPr>
          <a:xfrm>
            <a:off x="733293" y="460135"/>
            <a:ext cx="8724606" cy="5021489"/>
            <a:chOff x="733293" y="460135"/>
            <a:chExt cx="8724606" cy="5021489"/>
          </a:xfrm>
        </p:grpSpPr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FE93DE3E-8ED2-985A-6D19-48B46EE4E6DD}"/>
                </a:ext>
              </a:extLst>
            </p:cNvPr>
            <p:cNvGrpSpPr/>
            <p:nvPr/>
          </p:nvGrpSpPr>
          <p:grpSpPr>
            <a:xfrm>
              <a:off x="733293" y="460135"/>
              <a:ext cx="8724606" cy="5021489"/>
              <a:chOff x="733293" y="460135"/>
              <a:chExt cx="8724606" cy="5021489"/>
            </a:xfrm>
          </p:grpSpPr>
          <p:sp>
            <p:nvSpPr>
              <p:cNvPr id="3" name="CuadroTexto 2">
                <a:extLst>
                  <a:ext uri="{FF2B5EF4-FFF2-40B4-BE49-F238E27FC236}">
                    <a16:creationId xmlns:a16="http://schemas.microsoft.com/office/drawing/2014/main" id="{4164412A-E700-C846-0541-8ED98F8FB662}"/>
                  </a:ext>
                </a:extLst>
              </p:cNvPr>
              <p:cNvSpPr txBox="1"/>
              <p:nvPr/>
            </p:nvSpPr>
            <p:spPr>
              <a:xfrm>
                <a:off x="1098629" y="460135"/>
                <a:ext cx="223541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2400" b="1" dirty="0"/>
                  <a:t>Figure 5</a:t>
                </a:r>
              </a:p>
            </p:txBody>
          </p:sp>
          <p:grpSp>
            <p:nvGrpSpPr>
              <p:cNvPr id="2" name="Grupo 1">
                <a:extLst>
                  <a:ext uri="{FF2B5EF4-FFF2-40B4-BE49-F238E27FC236}">
                    <a16:creationId xmlns:a16="http://schemas.microsoft.com/office/drawing/2014/main" id="{58A63CCB-0E09-7DF9-7B71-515BB8ED97DE}"/>
                  </a:ext>
                </a:extLst>
              </p:cNvPr>
              <p:cNvGrpSpPr/>
              <p:nvPr/>
            </p:nvGrpSpPr>
            <p:grpSpPr>
              <a:xfrm>
                <a:off x="733293" y="1473897"/>
                <a:ext cx="7841872" cy="1008216"/>
                <a:chOff x="2660566" y="477414"/>
                <a:chExt cx="7841872" cy="1008216"/>
              </a:xfrm>
            </p:grpSpPr>
            <p:sp>
              <p:nvSpPr>
                <p:cNvPr id="24" name="10 CuadroTexto">
                  <a:extLst>
                    <a:ext uri="{FF2B5EF4-FFF2-40B4-BE49-F238E27FC236}">
                      <a16:creationId xmlns:a16="http://schemas.microsoft.com/office/drawing/2014/main" id="{ECAA19A9-B16E-413F-A707-6E7E055BA53E}"/>
                    </a:ext>
                  </a:extLst>
                </p:cNvPr>
                <p:cNvSpPr txBox="1"/>
                <p:nvPr/>
              </p:nvSpPr>
              <p:spPr>
                <a:xfrm>
                  <a:off x="8486214" y="477414"/>
                  <a:ext cx="201622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bulin (55 </a:t>
                  </a:r>
                  <a:r>
                    <a:rPr lang="en-US" sz="15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25" name="11 CuadroTexto">
                  <a:extLst>
                    <a:ext uri="{FF2B5EF4-FFF2-40B4-BE49-F238E27FC236}">
                      <a16:creationId xmlns:a16="http://schemas.microsoft.com/office/drawing/2014/main" id="{ECEC7DF6-0455-4B92-AC1A-39797CA1E19F}"/>
                    </a:ext>
                  </a:extLst>
                </p:cNvPr>
                <p:cNvSpPr txBox="1"/>
                <p:nvPr/>
              </p:nvSpPr>
              <p:spPr>
                <a:xfrm>
                  <a:off x="2660566" y="1162465"/>
                  <a:ext cx="1605293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R8 (41 </a:t>
                  </a:r>
                  <a:r>
                    <a:rPr lang="en-US" sz="15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</p:grpSp>
          <p:sp>
            <p:nvSpPr>
              <p:cNvPr id="8" name="CuadroTexto 7">
                <a:extLst>
                  <a:ext uri="{FF2B5EF4-FFF2-40B4-BE49-F238E27FC236}">
                    <a16:creationId xmlns:a16="http://schemas.microsoft.com/office/drawing/2014/main" id="{4D1D00F4-0ADE-D81D-973D-CB1C341EA80C}"/>
                  </a:ext>
                </a:extLst>
              </p:cNvPr>
              <p:cNvSpPr txBox="1"/>
              <p:nvPr/>
            </p:nvSpPr>
            <p:spPr>
              <a:xfrm>
                <a:off x="1815153" y="5112292"/>
                <a:ext cx="76427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Both (CCR8 and Tubulin) cropped from different parts of the different gels. </a:t>
                </a:r>
              </a:p>
            </p:txBody>
          </p:sp>
        </p:grpSp>
        <p:sp>
          <p:nvSpPr>
            <p:cNvPr id="5" name="8 CuadroTexto">
              <a:extLst>
                <a:ext uri="{FF2B5EF4-FFF2-40B4-BE49-F238E27FC236}">
                  <a16:creationId xmlns:a16="http://schemas.microsoft.com/office/drawing/2014/main" id="{C5EBC5B8-969C-6D93-C307-AEB36292DB2E}"/>
                </a:ext>
              </a:extLst>
            </p:cNvPr>
            <p:cNvSpPr txBox="1"/>
            <p:nvPr/>
          </p:nvSpPr>
          <p:spPr>
            <a:xfrm>
              <a:off x="2880254" y="4528838"/>
              <a:ext cx="22973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C // NOT // NOT+USGET</a:t>
              </a:r>
            </a:p>
          </p:txBody>
        </p:sp>
      </p:grpSp>
      <p:pic>
        <p:nvPicPr>
          <p:cNvPr id="20" name="Imagen 19">
            <a:extLst>
              <a:ext uri="{FF2B5EF4-FFF2-40B4-BE49-F238E27FC236}">
                <a16:creationId xmlns:a16="http://schemas.microsoft.com/office/drawing/2014/main" id="{636142AE-0506-C72E-3F4C-FC7BB3988C5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3794" t="16120" r="33892" b="30178"/>
          <a:stretch/>
        </p:blipFill>
        <p:spPr>
          <a:xfrm>
            <a:off x="2587562" y="302284"/>
            <a:ext cx="1864852" cy="2989556"/>
          </a:xfrm>
          <a:prstGeom prst="rect">
            <a:avLst/>
          </a:prstGeom>
        </p:spPr>
      </p:pic>
      <p:pic>
        <p:nvPicPr>
          <p:cNvPr id="7" name="Imagen 6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D23D8986-2962-BF24-E210-30C140B9771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848" t="50586" r="49871" b="19208"/>
          <a:stretch/>
        </p:blipFill>
        <p:spPr>
          <a:xfrm>
            <a:off x="4560255" y="302284"/>
            <a:ext cx="1890845" cy="2989556"/>
          </a:xfrm>
          <a:prstGeom prst="rect">
            <a:avLst/>
          </a:prstGeom>
          <a:ln w="15875"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904354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o 10">
            <a:extLst>
              <a:ext uri="{FF2B5EF4-FFF2-40B4-BE49-F238E27FC236}">
                <a16:creationId xmlns:a16="http://schemas.microsoft.com/office/drawing/2014/main" id="{94266E4F-359C-849D-400A-3D5A4FB65CF7}"/>
              </a:ext>
            </a:extLst>
          </p:cNvPr>
          <p:cNvGrpSpPr/>
          <p:nvPr/>
        </p:nvGrpSpPr>
        <p:grpSpPr>
          <a:xfrm>
            <a:off x="645830" y="64969"/>
            <a:ext cx="11005721" cy="6393876"/>
            <a:chOff x="645830" y="64969"/>
            <a:chExt cx="11005721" cy="6393876"/>
          </a:xfrm>
        </p:grpSpPr>
        <p:grpSp>
          <p:nvGrpSpPr>
            <p:cNvPr id="9" name="Grupo 8">
              <a:extLst>
                <a:ext uri="{FF2B5EF4-FFF2-40B4-BE49-F238E27FC236}">
                  <a16:creationId xmlns:a16="http://schemas.microsoft.com/office/drawing/2014/main" id="{DFCC8428-AE51-525A-4B66-022AC0F61743}"/>
                </a:ext>
              </a:extLst>
            </p:cNvPr>
            <p:cNvGrpSpPr/>
            <p:nvPr/>
          </p:nvGrpSpPr>
          <p:grpSpPr>
            <a:xfrm>
              <a:off x="645830" y="64969"/>
              <a:ext cx="3969770" cy="6393876"/>
              <a:chOff x="645830" y="64969"/>
              <a:chExt cx="3969770" cy="6393876"/>
            </a:xfrm>
          </p:grpSpPr>
          <p:grpSp>
            <p:nvGrpSpPr>
              <p:cNvPr id="5" name="Grupo 4">
                <a:extLst>
                  <a:ext uri="{FF2B5EF4-FFF2-40B4-BE49-F238E27FC236}">
                    <a16:creationId xmlns:a16="http://schemas.microsoft.com/office/drawing/2014/main" id="{36D66B2B-D87A-2E3A-CF3A-98303F148253}"/>
                  </a:ext>
                </a:extLst>
              </p:cNvPr>
              <p:cNvGrpSpPr/>
              <p:nvPr/>
            </p:nvGrpSpPr>
            <p:grpSpPr>
              <a:xfrm>
                <a:off x="645830" y="64969"/>
                <a:ext cx="3969770" cy="6393876"/>
                <a:chOff x="645830" y="121240"/>
                <a:chExt cx="3969770" cy="6393876"/>
              </a:xfrm>
            </p:grpSpPr>
            <p:sp>
              <p:nvSpPr>
                <p:cNvPr id="21" name="11 CuadroTexto">
                  <a:extLst>
                    <a:ext uri="{FF2B5EF4-FFF2-40B4-BE49-F238E27FC236}">
                      <a16:creationId xmlns:a16="http://schemas.microsoft.com/office/drawing/2014/main" id="{F39CA2F9-5B97-4AB3-8728-35AF1E24C1C9}"/>
                    </a:ext>
                  </a:extLst>
                </p:cNvPr>
                <p:cNvSpPr txBox="1"/>
                <p:nvPr/>
              </p:nvSpPr>
              <p:spPr>
                <a:xfrm>
                  <a:off x="3138896" y="2883585"/>
                  <a:ext cx="147670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F</a:t>
                  </a:r>
                  <a:r>
                    <a:rPr lang="en-US" sz="15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ᴋ</a:t>
                  </a:r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 (65 </a:t>
                  </a:r>
                  <a:r>
                    <a:rPr lang="en-US" sz="15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3" name="CuadroTexto 2">
                  <a:extLst>
                    <a:ext uri="{FF2B5EF4-FFF2-40B4-BE49-F238E27FC236}">
                      <a16:creationId xmlns:a16="http://schemas.microsoft.com/office/drawing/2014/main" id="{DFE262E2-2764-1A52-F272-74877F993D42}"/>
                    </a:ext>
                  </a:extLst>
                </p:cNvPr>
                <p:cNvSpPr txBox="1"/>
                <p:nvPr/>
              </p:nvSpPr>
              <p:spPr>
                <a:xfrm>
                  <a:off x="645830" y="121240"/>
                  <a:ext cx="1389610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2400" b="1" dirty="0"/>
                    <a:t>Figure 6</a:t>
                  </a:r>
                </a:p>
              </p:txBody>
            </p:sp>
            <p:sp>
              <p:nvSpPr>
                <p:cNvPr id="25" name="CuadroTexto 24">
                  <a:extLst>
                    <a:ext uri="{FF2B5EF4-FFF2-40B4-BE49-F238E27FC236}">
                      <a16:creationId xmlns:a16="http://schemas.microsoft.com/office/drawing/2014/main" id="{4F4484B6-34A3-621A-E864-0BD890375B2E}"/>
                    </a:ext>
                  </a:extLst>
                </p:cNvPr>
                <p:cNvSpPr txBox="1"/>
                <p:nvPr/>
              </p:nvSpPr>
              <p:spPr>
                <a:xfrm>
                  <a:off x="1015420" y="5591786"/>
                  <a:ext cx="2819836" cy="9233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Both (NF</a:t>
                  </a:r>
                  <a:r>
                    <a:rPr lang="el-GR" dirty="0">
                      <a:latin typeface="Century Gothic" panose="020B050202020202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κ</a:t>
                  </a:r>
                  <a:r>
                    <a:rPr lang="en-US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B and Tubulin) cropped from different parts of the different gels. </a:t>
                  </a:r>
                </a:p>
              </p:txBody>
            </p:sp>
          </p:grpSp>
          <p:sp>
            <p:nvSpPr>
              <p:cNvPr id="7" name="8 CuadroTexto">
                <a:extLst>
                  <a:ext uri="{FF2B5EF4-FFF2-40B4-BE49-F238E27FC236}">
                    <a16:creationId xmlns:a16="http://schemas.microsoft.com/office/drawing/2014/main" id="{C87FD766-1449-F399-D9FD-B70C4D9CA53D}"/>
                  </a:ext>
                </a:extLst>
              </p:cNvPr>
              <p:cNvSpPr txBox="1"/>
              <p:nvPr/>
            </p:nvSpPr>
            <p:spPr>
              <a:xfrm>
                <a:off x="1474548" y="5139910"/>
                <a:ext cx="22973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 // NOT // NOT+USGET</a:t>
                </a:r>
              </a:p>
            </p:txBody>
          </p:sp>
        </p:grpSp>
        <p:grpSp>
          <p:nvGrpSpPr>
            <p:cNvPr id="10" name="Grupo 9">
              <a:extLst>
                <a:ext uri="{FF2B5EF4-FFF2-40B4-BE49-F238E27FC236}">
                  <a16:creationId xmlns:a16="http://schemas.microsoft.com/office/drawing/2014/main" id="{F5D091D6-FED0-7C1D-F3B9-3DF62AE5F27E}"/>
                </a:ext>
              </a:extLst>
            </p:cNvPr>
            <p:cNvGrpSpPr/>
            <p:nvPr/>
          </p:nvGrpSpPr>
          <p:grpSpPr>
            <a:xfrm>
              <a:off x="4657289" y="2749077"/>
              <a:ext cx="6994262" cy="3119103"/>
              <a:chOff x="4657289" y="2749077"/>
              <a:chExt cx="6994262" cy="3119103"/>
            </a:xfrm>
          </p:grpSpPr>
          <p:grpSp>
            <p:nvGrpSpPr>
              <p:cNvPr id="6" name="Grupo 5">
                <a:extLst>
                  <a:ext uri="{FF2B5EF4-FFF2-40B4-BE49-F238E27FC236}">
                    <a16:creationId xmlns:a16="http://schemas.microsoft.com/office/drawing/2014/main" id="{08325BB9-9FC8-C142-F642-AA2854C69734}"/>
                  </a:ext>
                </a:extLst>
              </p:cNvPr>
              <p:cNvGrpSpPr/>
              <p:nvPr/>
            </p:nvGrpSpPr>
            <p:grpSpPr>
              <a:xfrm>
                <a:off x="6318914" y="2749077"/>
                <a:ext cx="5332637" cy="3119103"/>
                <a:chOff x="6319589" y="1575634"/>
                <a:chExt cx="5332637" cy="3119103"/>
              </a:xfrm>
            </p:grpSpPr>
            <p:sp>
              <p:nvSpPr>
                <p:cNvPr id="22" name="10 CuadroTexto">
                  <a:extLst>
                    <a:ext uri="{FF2B5EF4-FFF2-40B4-BE49-F238E27FC236}">
                      <a16:creationId xmlns:a16="http://schemas.microsoft.com/office/drawing/2014/main" id="{2983D01F-5921-4118-8637-C0DED1CE7F5D}"/>
                    </a:ext>
                  </a:extLst>
                </p:cNvPr>
                <p:cNvSpPr txBox="1"/>
                <p:nvPr/>
              </p:nvSpPr>
              <p:spPr>
                <a:xfrm>
                  <a:off x="6456623" y="1575634"/>
                  <a:ext cx="201622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bulin 55</a:t>
                  </a:r>
                </a:p>
              </p:txBody>
            </p:sp>
            <p:sp>
              <p:nvSpPr>
                <p:cNvPr id="23" name="11 CuadroTexto">
                  <a:extLst>
                    <a:ext uri="{FF2B5EF4-FFF2-40B4-BE49-F238E27FC236}">
                      <a16:creationId xmlns:a16="http://schemas.microsoft.com/office/drawing/2014/main" id="{697010DB-0D37-44E8-A5B6-DA4BE42089CA}"/>
                    </a:ext>
                  </a:extLst>
                </p:cNvPr>
                <p:cNvSpPr txBox="1"/>
                <p:nvPr/>
              </p:nvSpPr>
              <p:spPr>
                <a:xfrm>
                  <a:off x="10212839" y="1653871"/>
                  <a:ext cx="1439387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r>
                    <a:rPr lang="en-US" sz="15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ᴋ</a:t>
                  </a:r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 41 (</a:t>
                  </a:r>
                  <a:r>
                    <a:rPr lang="en-US" sz="15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r>
                    <a:rPr lang="en-US" sz="1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26" name="CuadroTexto 25">
                  <a:extLst>
                    <a:ext uri="{FF2B5EF4-FFF2-40B4-BE49-F238E27FC236}">
                      <a16:creationId xmlns:a16="http://schemas.microsoft.com/office/drawing/2014/main" id="{22783C2D-6824-CAF2-93C6-598ABEBDF34A}"/>
                    </a:ext>
                  </a:extLst>
                </p:cNvPr>
                <p:cNvSpPr txBox="1"/>
                <p:nvPr/>
              </p:nvSpPr>
              <p:spPr>
                <a:xfrm>
                  <a:off x="6319589" y="4048406"/>
                  <a:ext cx="4612944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Both (I</a:t>
                  </a:r>
                  <a:r>
                    <a:rPr lang="el-GR" dirty="0">
                      <a:latin typeface="Century Gothic" panose="020B050202020202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κ</a:t>
                  </a:r>
                  <a:r>
                    <a:rPr lang="en-US" dirty="0"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B and Tubulin) cropped from different parts of the different gels. </a:t>
                  </a:r>
                </a:p>
              </p:txBody>
            </p:sp>
          </p:grpSp>
          <p:sp>
            <p:nvSpPr>
              <p:cNvPr id="8" name="8 CuadroTexto">
                <a:extLst>
                  <a:ext uri="{FF2B5EF4-FFF2-40B4-BE49-F238E27FC236}">
                    <a16:creationId xmlns:a16="http://schemas.microsoft.com/office/drawing/2014/main" id="{1FCAB041-BBF7-322C-A98D-D3099C0F6976}"/>
                  </a:ext>
                </a:extLst>
              </p:cNvPr>
              <p:cNvSpPr txBox="1"/>
              <p:nvPr/>
            </p:nvSpPr>
            <p:spPr>
              <a:xfrm>
                <a:off x="4657289" y="4748712"/>
                <a:ext cx="22973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 // NOT // NOT+USGET</a:t>
                </a:r>
              </a:p>
            </p:txBody>
          </p:sp>
        </p:grpSp>
      </p:grpSp>
      <p:pic>
        <p:nvPicPr>
          <p:cNvPr id="13" name="Imagen 12">
            <a:extLst>
              <a:ext uri="{FF2B5EF4-FFF2-40B4-BE49-F238E27FC236}">
                <a16:creationId xmlns:a16="http://schemas.microsoft.com/office/drawing/2014/main" id="{2400B7AE-D739-258F-9150-3486DE5BC1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623" t="19702" r="29279" b="17553"/>
          <a:stretch/>
        </p:blipFill>
        <p:spPr>
          <a:xfrm>
            <a:off x="1069758" y="699383"/>
            <a:ext cx="1982739" cy="3572365"/>
          </a:xfrm>
          <a:prstGeom prst="rect">
            <a:avLst/>
          </a:prstGeom>
        </p:spPr>
      </p:pic>
      <p:pic>
        <p:nvPicPr>
          <p:cNvPr id="28" name="Imagen 27">
            <a:extLst>
              <a:ext uri="{FF2B5EF4-FFF2-40B4-BE49-F238E27FC236}">
                <a16:creationId xmlns:a16="http://schemas.microsoft.com/office/drawing/2014/main" id="{1392FB7B-573B-06D6-AC30-14ABFDD0CC4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320" t="4012" r="2019" b="6565"/>
          <a:stretch/>
        </p:blipFill>
        <p:spPr>
          <a:xfrm>
            <a:off x="4615600" y="699383"/>
            <a:ext cx="1798659" cy="3434489"/>
          </a:xfrm>
          <a:prstGeom prst="rect">
            <a:avLst/>
          </a:prstGeom>
        </p:spPr>
      </p:pic>
      <p:pic>
        <p:nvPicPr>
          <p:cNvPr id="29" name="Imagen 28">
            <a:extLst>
              <a:ext uri="{FF2B5EF4-FFF2-40B4-BE49-F238E27FC236}">
                <a16:creationId xmlns:a16="http://schemas.microsoft.com/office/drawing/2014/main" id="{C07CDFB7-C764-DC4E-27B7-6322C5D00DB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5030"/>
          <a:stretch/>
        </p:blipFill>
        <p:spPr>
          <a:xfrm>
            <a:off x="7742594" y="768320"/>
            <a:ext cx="2297329" cy="3434489"/>
          </a:xfrm>
          <a:prstGeom prst="rect">
            <a:avLst/>
          </a:prstGeom>
        </p:spPr>
      </p:pic>
      <p:sp>
        <p:nvSpPr>
          <p:cNvPr id="30" name="8 CuadroTexto">
            <a:extLst>
              <a:ext uri="{FF2B5EF4-FFF2-40B4-BE49-F238E27FC236}">
                <a16:creationId xmlns:a16="http://schemas.microsoft.com/office/drawing/2014/main" id="{F4191A28-778F-BC29-4334-74D248B59306}"/>
              </a:ext>
            </a:extLst>
          </p:cNvPr>
          <p:cNvSpPr txBox="1"/>
          <p:nvPr/>
        </p:nvSpPr>
        <p:spPr>
          <a:xfrm>
            <a:off x="8235277" y="4589518"/>
            <a:ext cx="2297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C // NOT // NOT+USGET</a:t>
            </a:r>
          </a:p>
        </p:txBody>
      </p:sp>
    </p:spTree>
    <p:extLst>
      <p:ext uri="{BB962C8B-B14F-4D97-AF65-F5344CB8AC3E}">
        <p14:creationId xmlns:p14="http://schemas.microsoft.com/office/powerpoint/2010/main" val="7243630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4</TotalTime>
  <Words>142</Words>
  <Application>Microsoft Office PowerPoint</Application>
  <PresentationFormat>Panorámica</PresentationFormat>
  <Paragraphs>19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entury Gothic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oraya L.</dc:creator>
  <cp:lastModifiedBy>Soraya L.</cp:lastModifiedBy>
  <cp:revision>78</cp:revision>
  <dcterms:created xsi:type="dcterms:W3CDTF">2021-02-04T08:38:29Z</dcterms:created>
  <dcterms:modified xsi:type="dcterms:W3CDTF">2022-10-01T15:02:30Z</dcterms:modified>
</cp:coreProperties>
</file>